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797675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5" d="100"/>
          <a:sy n="65" d="100"/>
        </p:scale>
        <p:origin x="114" y="2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308C849-C5D3-BC74-A69C-AD79D34586F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2A81DE43-3B77-F07F-A26D-908DFF445F4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822392F-5956-E8A2-F5A1-C7A5F2610B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59F99-A870-4ADF-837A-A22F939E8986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24D0CB2-58DF-F497-6E67-4CDFFF75A6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7E3E868-5EFE-1215-DFBD-EA7E3BBD47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7D6A-A751-4520-B95A-BDC6C88D09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299865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BA493B6-4AEC-5D00-CD7C-436E9125B6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1993D7B7-5902-05C2-7DD1-3AD6652C51B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E08AC97-86FF-C773-00CB-47074C049C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59F99-A870-4ADF-837A-A22F939E8986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A381F42-08DC-C076-1CDF-B9329DA3DD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45A8A65-9A33-B401-48EA-97DBFD22BB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7D6A-A751-4520-B95A-BDC6C88D09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561822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000B0DA2-2723-8D71-1FE3-1DFE5AF934F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997601C7-BEBF-2D92-E0EE-D9BF61F197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9BD088B-9F43-3B38-2058-EC54405121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59F99-A870-4ADF-837A-A22F939E8986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1A75DA4-45D3-1751-D0A8-460AFE619D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3F33800-02AE-5BF1-0C50-96A29B6426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7D6A-A751-4520-B95A-BDC6C88D09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394220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6820BFB-E883-B657-65B9-9BA3F0EADA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EC9682AC-1A18-A801-0D84-4E27A3AFF50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48A41DB-F803-60FB-99E0-E99182412E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59F99-A870-4ADF-837A-A22F939E8986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AB984EA-4553-E6DC-93AB-0BE246DAD2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2F3BAA8-DA7F-63CE-91C3-741C10BA28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7D6A-A751-4520-B95A-BDC6C88D09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774196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FFD984B-A460-A92F-D85F-C402B5EA0E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9F2B132D-54E1-2D97-0BC0-B34F497F1B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EE176B6-B42C-184A-E6F0-7932E5334D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59F99-A870-4ADF-837A-A22F939E8986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4FED95D-5966-CE6E-E863-792BE1CA8E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5B4A4BF-2FE4-26C4-DEA4-C326071EFC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7D6A-A751-4520-B95A-BDC6C88D09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70465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38B61E7-8B00-73C4-0B38-EACD151FDE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BAF2048A-0B21-6D52-07A3-91A6225196B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A3744A9C-1163-8273-20CA-5A36EFCF1F6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14850128-8A1C-49C3-D377-809E263E46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59F99-A870-4ADF-837A-A22F939E8986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96101478-A298-DED6-AF2A-576D48E2BF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D3F9C1B7-1A9D-4ABE-872E-4A0E6EAB53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7D6A-A751-4520-B95A-BDC6C88D09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787516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D86A49D-9649-FC18-F7D4-7B4426CE6B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2E57CB6F-B513-0806-B44D-1CEE494E37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B6EEEAAD-3449-C8E4-4073-92EFF93C16A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A9C039A9-E3A7-AC38-9397-B2F80C8F761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222384FC-F7E9-3A5F-184C-3E7F1D8DBC2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8527200E-0AC5-7322-D8B9-00E276D01B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59F99-A870-4ADF-837A-A22F939E8986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2DC1FE07-F537-9CF9-2278-5FCE361CBF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BBA4D424-AFB0-E7FF-BEBE-9BB5273D0F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7D6A-A751-4520-B95A-BDC6C88D09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773361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5AF2EEB-4AD4-D2A4-6AAA-86BCCBAD6A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0A6E80F3-2E89-9E65-00A5-13D43B512D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59F99-A870-4ADF-837A-A22F939E8986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BC86DA8B-B8A3-CD20-2495-DC794EE161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6C772A4D-C196-C6B8-C77D-1ACB235A51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7D6A-A751-4520-B95A-BDC6C88D09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608591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80523264-7066-3D95-6208-ED53C5F35B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59F99-A870-4ADF-837A-A22F939E8986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3B94F1E4-25FC-7E55-C223-800990C033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3D09919F-DE63-77B3-9A80-C26D826E62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7D6A-A751-4520-B95A-BDC6C88D09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814343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77DC40E-25C8-E508-2989-27E0B46776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01B161E-F43A-FAF5-CF95-2FECE562886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321EDF45-7C31-2E16-DC75-FD7AA0CABE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469F8FB1-C2FF-0FCC-3A0E-CC5A70F72B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59F99-A870-4ADF-837A-A22F939E8986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9E631C04-CB13-7FF5-7803-F995390253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9AA80456-6455-F392-3E68-4D0D22C451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7D6A-A751-4520-B95A-BDC6C88D09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75636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8152437-243F-2F43-6B6E-28F5E277E7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7BEAC857-4958-3BCD-127F-501800B7394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F74C58C3-016E-19AB-5925-93D4C6ACEA7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24D39F13-1FD4-D3FE-EF38-EFC3317F93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59F99-A870-4ADF-837A-A22F939E8986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4C0D088-F2A2-85F0-CD4C-7A41CB9180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E9ED6DD1-233A-1A5D-DD54-1C26997005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37D6A-A751-4520-B95A-BDC6C88D09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346092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8954533F-4D59-1CF3-19B8-35007B059F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B6EF467A-8999-2234-D048-70FF6B41D5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0565F20-A48A-C901-016E-2131692E25B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F59F99-A870-4ADF-837A-A22F939E8986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86862D5-0D3B-A0B8-8105-F51E0A6E35C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D123C0D-9D32-B830-67A6-E76F44F31D5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337D6A-A751-4520-B95A-BDC6C88D09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940161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" name="Image 33" descr="Une image contenant texte, intérieur&#10;&#10;Description générée automatiquement">
            <a:extLst>
              <a:ext uri="{FF2B5EF4-FFF2-40B4-BE49-F238E27FC236}">
                <a16:creationId xmlns:a16="http://schemas.microsoft.com/office/drawing/2014/main" id="{E3F91E02-6300-7743-C876-413A87C4FD09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098" b="5028"/>
          <a:stretch/>
        </p:blipFill>
        <p:spPr>
          <a:xfrm>
            <a:off x="5325193" y="3332678"/>
            <a:ext cx="3479798" cy="242197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2" name="Image 31" descr="Une image contenant carte&#10;&#10;Description générée automatiquement">
            <a:extLst>
              <a:ext uri="{FF2B5EF4-FFF2-40B4-BE49-F238E27FC236}">
                <a16:creationId xmlns:a16="http://schemas.microsoft.com/office/drawing/2014/main" id="{FDE16254-1D3D-80E9-F851-D8E776607D21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514"/>
          <a:stretch/>
        </p:blipFill>
        <p:spPr>
          <a:xfrm>
            <a:off x="1452042" y="3352873"/>
            <a:ext cx="3695163" cy="240177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8" name="Image 27" descr="Une image contenant carte&#10;&#10;Description générée automatiquement">
            <a:extLst>
              <a:ext uri="{FF2B5EF4-FFF2-40B4-BE49-F238E27FC236}">
                <a16:creationId xmlns:a16="http://schemas.microsoft.com/office/drawing/2014/main" id="{2E7657CC-0DFB-2349-AB2D-E2B46AAC98FE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030"/>
          <a:stretch/>
        </p:blipFill>
        <p:spPr>
          <a:xfrm>
            <a:off x="5334704" y="445036"/>
            <a:ext cx="3479798" cy="275184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6" name="Image 25" descr="Une image contenant texte, intérieur, mur&#10;&#10;Description générée automatiquement">
            <a:extLst>
              <a:ext uri="{FF2B5EF4-FFF2-40B4-BE49-F238E27FC236}">
                <a16:creationId xmlns:a16="http://schemas.microsoft.com/office/drawing/2014/main" id="{A59E5ACA-12ED-A90E-4DE8-B1CB27A89890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64"/>
          <a:stretch/>
        </p:blipFill>
        <p:spPr>
          <a:xfrm>
            <a:off x="1473599" y="436040"/>
            <a:ext cx="3673606" cy="276061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ZoneTexte 8">
            <a:extLst>
              <a:ext uri="{FF2B5EF4-FFF2-40B4-BE49-F238E27FC236}">
                <a16:creationId xmlns:a16="http://schemas.microsoft.com/office/drawing/2014/main" id="{E61AA91B-1B03-6DB2-4D56-00C8AD43E736}"/>
              </a:ext>
            </a:extLst>
          </p:cNvPr>
          <p:cNvSpPr txBox="1"/>
          <p:nvPr/>
        </p:nvSpPr>
        <p:spPr>
          <a:xfrm>
            <a:off x="-198120" y="5890445"/>
            <a:ext cx="8892540" cy="4431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indent="269875" algn="ctr">
              <a:lnSpc>
                <a:spcPct val="95000"/>
              </a:lnSpc>
              <a:spcAft>
                <a:spcPts val="800"/>
              </a:spcAft>
              <a:tabLst>
                <a:tab pos="3379470" algn="l"/>
              </a:tabLst>
            </a:pPr>
            <a:r>
              <a:rPr lang="en-US" sz="12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4.</a:t>
            </a:r>
            <a:r>
              <a:rPr lang="en-US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Histological pictures of actinic keratoses (AK) that were classified by the transcriptomic analysis as “non-</a:t>
            </a:r>
            <a:r>
              <a:rPr lang="en-US" sz="12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esional</a:t>
            </a:r>
            <a:r>
              <a:rPr lang="en-US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” (AK_NL).</a:t>
            </a:r>
            <a:endParaRPr lang="fr-FR" sz="1200" dirty="0">
              <a:solidFill>
                <a:srgbClr val="000000"/>
              </a:solidFill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AC7D7CF7-13DC-690A-7C73-433F543F244D}"/>
              </a:ext>
            </a:extLst>
          </p:cNvPr>
          <p:cNvSpPr/>
          <p:nvPr/>
        </p:nvSpPr>
        <p:spPr>
          <a:xfrm>
            <a:off x="1481218" y="2963798"/>
            <a:ext cx="1058333" cy="21336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01_C_AK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68791660-E67F-2F67-1598-3F13FE36113E}"/>
              </a:ext>
            </a:extLst>
          </p:cNvPr>
          <p:cNvSpPr/>
          <p:nvPr/>
        </p:nvSpPr>
        <p:spPr>
          <a:xfrm>
            <a:off x="5337774" y="5532985"/>
            <a:ext cx="1304207" cy="21336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19_C_AK_2</a:t>
            </a: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13176B2D-6B7E-D45B-0C07-D24AA3EA79D4}"/>
              </a:ext>
            </a:extLst>
          </p:cNvPr>
          <p:cNvSpPr/>
          <p:nvPr/>
        </p:nvSpPr>
        <p:spPr>
          <a:xfrm>
            <a:off x="5353014" y="2963798"/>
            <a:ext cx="1200186" cy="21336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41_A_AK</a:t>
            </a: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0E8870D2-6971-B560-2C6C-A51DB9BEC96B}"/>
              </a:ext>
            </a:extLst>
          </p:cNvPr>
          <p:cNvSpPr/>
          <p:nvPr/>
        </p:nvSpPr>
        <p:spPr>
          <a:xfrm>
            <a:off x="1459963" y="5526580"/>
            <a:ext cx="1229897" cy="21336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9_C’_AK_1</a:t>
            </a:r>
          </a:p>
        </p:txBody>
      </p:sp>
    </p:spTree>
    <p:extLst>
      <p:ext uri="{BB962C8B-B14F-4D97-AF65-F5344CB8AC3E}">
        <p14:creationId xmlns:p14="http://schemas.microsoft.com/office/powerpoint/2010/main" val="296111421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7</TotalTime>
  <Words>51</Words>
  <Application>Microsoft Office PowerPoint</Application>
  <PresentationFormat>Grand écran</PresentationFormat>
  <Paragraphs>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Helene Dubois-Pot-Schneider</dc:creator>
  <cp:lastModifiedBy>Helene Dubois-Pot-Schneider</cp:lastModifiedBy>
  <cp:revision>5</cp:revision>
  <cp:lastPrinted>2023-02-20T14:56:07Z</cp:lastPrinted>
  <dcterms:created xsi:type="dcterms:W3CDTF">2023-02-20T13:58:04Z</dcterms:created>
  <dcterms:modified xsi:type="dcterms:W3CDTF">2023-02-21T14:19:19Z</dcterms:modified>
</cp:coreProperties>
</file>